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handoutMasterIdLst>
    <p:handoutMasterId r:id="rId3"/>
  </p:handoutMasterIdLst>
  <p:sldIdLst>
    <p:sldId id="257" r:id="rId2"/>
  </p:sldIdLst>
  <p:sldSz cx="6858000" cy="9144000" type="screen4x3"/>
  <p:notesSz cx="6807200" cy="993933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 snapToObjects="1">
      <p:cViewPr>
        <p:scale>
          <a:sx n="60" d="100"/>
          <a:sy n="60" d="100"/>
        </p:scale>
        <p:origin x="-1422" y="-13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hoko%20Ichihara\Documents\MTS%20CNTs%20supp%20fina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Sheet1!$B$12:$H$12</c:f>
                <c:numCache>
                  <c:formatCode>General</c:formatCode>
                  <c:ptCount val="7"/>
                  <c:pt idx="0">
                    <c:v>7.0840992232997095</c:v>
                  </c:pt>
                  <c:pt idx="1">
                    <c:v>7.0649270657554828</c:v>
                  </c:pt>
                  <c:pt idx="2">
                    <c:v>4.7163464261132351</c:v>
                  </c:pt>
                  <c:pt idx="3">
                    <c:v>3.3633092272839455</c:v>
                  </c:pt>
                  <c:pt idx="4">
                    <c:v>7.2450144496060176</c:v>
                  </c:pt>
                  <c:pt idx="5">
                    <c:v>2.0637096620998885</c:v>
                  </c:pt>
                  <c:pt idx="6">
                    <c:v>2.885811495248972</c:v>
                  </c:pt>
                </c:numCache>
              </c:numRef>
            </c:plus>
            <c:minus>
              <c:numRef>
                <c:f>Sheet1!$B$12:$H$12</c:f>
                <c:numCache>
                  <c:formatCode>General</c:formatCode>
                  <c:ptCount val="7"/>
                  <c:pt idx="0">
                    <c:v>7.0840992232997095</c:v>
                  </c:pt>
                  <c:pt idx="1">
                    <c:v>7.0649270657554828</c:v>
                  </c:pt>
                  <c:pt idx="2">
                    <c:v>4.7163464261132351</c:v>
                  </c:pt>
                  <c:pt idx="3">
                    <c:v>3.3633092272839455</c:v>
                  </c:pt>
                  <c:pt idx="4">
                    <c:v>7.2450144496060176</c:v>
                  </c:pt>
                  <c:pt idx="5">
                    <c:v>2.0637096620998885</c:v>
                  </c:pt>
                  <c:pt idx="6">
                    <c:v>2.885811495248972</c:v>
                  </c:pt>
                </c:numCache>
              </c:numRef>
            </c:minus>
          </c:errBars>
          <c:cat>
            <c:strRef>
              <c:f>Sheet1!$B$1:$H$1</c:f>
              <c:strCache>
                <c:ptCount val="7"/>
                <c:pt idx="0">
                  <c:v>CTL</c:v>
                </c:pt>
                <c:pt idx="1">
                  <c:v>S2.5</c:v>
                </c:pt>
                <c:pt idx="2">
                  <c:v>S25</c:v>
                </c:pt>
                <c:pt idx="3">
                  <c:v>S50</c:v>
                </c:pt>
                <c:pt idx="4">
                  <c:v>D2.5</c:v>
                </c:pt>
                <c:pt idx="5">
                  <c:v>D25</c:v>
                </c:pt>
                <c:pt idx="6">
                  <c:v>D50</c:v>
                </c:pt>
              </c:strCache>
            </c:strRef>
          </c:cat>
          <c:val>
            <c:numRef>
              <c:f>Sheet1!$B$11:$H$11</c:f>
              <c:numCache>
                <c:formatCode>General</c:formatCode>
                <c:ptCount val="7"/>
                <c:pt idx="0">
                  <c:v>100</c:v>
                </c:pt>
                <c:pt idx="1">
                  <c:v>98.958333333333343</c:v>
                </c:pt>
                <c:pt idx="2">
                  <c:v>72.916666666666657</c:v>
                </c:pt>
                <c:pt idx="3">
                  <c:v>55.104166666666664</c:v>
                </c:pt>
                <c:pt idx="4">
                  <c:v>105.20833333333333</c:v>
                </c:pt>
                <c:pt idx="5">
                  <c:v>61.041666666666657</c:v>
                </c:pt>
                <c:pt idx="6">
                  <c:v>42.0833333333333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74808704"/>
        <c:axId val="75203712"/>
      </c:barChart>
      <c:catAx>
        <c:axId val="7480870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75203712"/>
        <c:crosses val="autoZero"/>
        <c:auto val="1"/>
        <c:lblAlgn val="ctr"/>
        <c:lblOffset val="100"/>
        <c:noMultiLvlLbl val="0"/>
      </c:catAx>
      <c:valAx>
        <c:axId val="752037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+mn-lt"/>
              </a:defRPr>
            </a:pPr>
            <a:endParaRPr lang="ja-JP"/>
          </a:p>
        </c:txPr>
        <c:crossAx val="74808704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643CE9-720A-4D2A-A362-4D562EC292FF}" type="datetimeFigureOut">
              <a:rPr kumimoji="1" lang="ja-JP" altLang="en-US" smtClean="0"/>
              <a:pPr/>
              <a:t>2016/10/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1E4C3F-F9D4-48F0-A1E0-7E9335D8F24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3318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701F-5208-7040-95BE-DC806E3FFE97}" type="datetimeFigureOut">
              <a:rPr kumimoji="1" lang="ja-JP" altLang="en-US" smtClean="0"/>
              <a:pPr/>
              <a:t>2016/10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2A9DC-7929-CD44-A788-52BDA5C497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3153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701F-5208-7040-95BE-DC806E3FFE97}" type="datetimeFigureOut">
              <a:rPr kumimoji="1" lang="ja-JP" altLang="en-US" smtClean="0"/>
              <a:pPr/>
              <a:t>2016/10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2A9DC-7929-CD44-A788-52BDA5C497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602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701F-5208-7040-95BE-DC806E3FFE97}" type="datetimeFigureOut">
              <a:rPr kumimoji="1" lang="ja-JP" altLang="en-US" smtClean="0"/>
              <a:pPr/>
              <a:t>2016/10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2A9DC-7929-CD44-A788-52BDA5C497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7900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701F-5208-7040-95BE-DC806E3FFE97}" type="datetimeFigureOut">
              <a:rPr kumimoji="1" lang="ja-JP" altLang="en-US" smtClean="0"/>
              <a:pPr/>
              <a:t>2016/10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2A9DC-7929-CD44-A788-52BDA5C497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7520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701F-5208-7040-95BE-DC806E3FFE97}" type="datetimeFigureOut">
              <a:rPr kumimoji="1" lang="ja-JP" altLang="en-US" smtClean="0"/>
              <a:pPr/>
              <a:t>2016/10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2A9DC-7929-CD44-A788-52BDA5C497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6929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701F-5208-7040-95BE-DC806E3FFE97}" type="datetimeFigureOut">
              <a:rPr kumimoji="1" lang="ja-JP" altLang="en-US" smtClean="0"/>
              <a:pPr/>
              <a:t>2016/10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2A9DC-7929-CD44-A788-52BDA5C497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3835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701F-5208-7040-95BE-DC806E3FFE97}" type="datetimeFigureOut">
              <a:rPr kumimoji="1" lang="ja-JP" altLang="en-US" smtClean="0"/>
              <a:pPr/>
              <a:t>2016/10/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2A9DC-7929-CD44-A788-52BDA5C497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12114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701F-5208-7040-95BE-DC806E3FFE97}" type="datetimeFigureOut">
              <a:rPr kumimoji="1" lang="ja-JP" altLang="en-US" smtClean="0"/>
              <a:pPr/>
              <a:t>2016/10/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2A9DC-7929-CD44-A788-52BDA5C497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1736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701F-5208-7040-95BE-DC806E3FFE97}" type="datetimeFigureOut">
              <a:rPr kumimoji="1" lang="ja-JP" altLang="en-US" smtClean="0"/>
              <a:pPr/>
              <a:t>2016/10/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2A9DC-7929-CD44-A788-52BDA5C497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2923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701F-5208-7040-95BE-DC806E3FFE97}" type="datetimeFigureOut">
              <a:rPr kumimoji="1" lang="ja-JP" altLang="en-US" smtClean="0"/>
              <a:pPr/>
              <a:t>2016/10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2A9DC-7929-CD44-A788-52BDA5C497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7310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701F-5208-7040-95BE-DC806E3FFE97}" type="datetimeFigureOut">
              <a:rPr kumimoji="1" lang="ja-JP" altLang="en-US" smtClean="0"/>
              <a:pPr/>
              <a:t>2016/10/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C2A9DC-7929-CD44-A788-52BDA5C497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6802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D1701F-5208-7040-95BE-DC806E3FFE97}" type="datetimeFigureOut">
              <a:rPr kumimoji="1" lang="ja-JP" altLang="en-US" smtClean="0"/>
              <a:pPr/>
              <a:t>2016/10/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2A9DC-7929-CD44-A788-52BDA5C497F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2136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正方形/長方形 60"/>
          <p:cNvSpPr/>
          <p:nvPr/>
        </p:nvSpPr>
        <p:spPr>
          <a:xfrm>
            <a:off x="589616" y="6045810"/>
            <a:ext cx="5779653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 smtClean="0"/>
              <a:t>Supplementary Figure </a:t>
            </a:r>
            <a:r>
              <a:rPr lang="en-US" altLang="ja-JP" b="1" dirty="0"/>
              <a:t>1. Effects of SWCNTs and DWCNTs on cell viability. </a:t>
            </a:r>
            <a:r>
              <a:rPr lang="en-US" altLang="ja-JP" dirty="0"/>
              <a:t>Cell viability was measured by cell viability assay kit. HAECs were exposed to CNTs at concentrations ranging from </a:t>
            </a:r>
            <a:r>
              <a:rPr lang="en-US" altLang="ja-JP" dirty="0" smtClean="0"/>
              <a:t>2.5 </a:t>
            </a:r>
            <a:r>
              <a:rPr lang="en-US" altLang="ja-JP" dirty="0"/>
              <a:t>to </a:t>
            </a:r>
            <a:r>
              <a:rPr lang="en-US" altLang="ja-JP" dirty="0" smtClean="0"/>
              <a:t>50 </a:t>
            </a:r>
            <a:r>
              <a:rPr lang="en-US" altLang="ja-JP" dirty="0" err="1"/>
              <a:t>μg</a:t>
            </a:r>
            <a:r>
              <a:rPr lang="en-US" altLang="ja-JP" dirty="0"/>
              <a:t>/ml for 16 hours. Data are </a:t>
            </a:r>
            <a:r>
              <a:rPr lang="en-US" altLang="ja-JP" dirty="0" err="1"/>
              <a:t>mean±SD</a:t>
            </a:r>
            <a:r>
              <a:rPr lang="en-US" altLang="ja-JP" dirty="0"/>
              <a:t>. (</a:t>
            </a:r>
            <a:r>
              <a:rPr lang="en-US" altLang="ja-JP" dirty="0" smtClean="0"/>
              <a:t>n=4, </a:t>
            </a:r>
            <a:r>
              <a:rPr lang="en-US" altLang="ja-JP" dirty="0"/>
              <a:t>*</a:t>
            </a:r>
            <a:r>
              <a:rPr lang="en-US" altLang="ja-JP" i="1" dirty="0"/>
              <a:t>p</a:t>
            </a:r>
            <a:r>
              <a:rPr lang="en-US" altLang="ja-JP" dirty="0"/>
              <a:t> &lt; 0.05 vs. control; CTL) HAEC: normal human aortic endothelial cell, SWCNT: single wall carbon nanotube, DWCNT: double wall carbon nanotube.</a:t>
            </a:r>
            <a:endParaRPr lang="ja-JP" altLang="en-US" dirty="0"/>
          </a:p>
          <a:p>
            <a:endParaRPr lang="ja-JP" altLang="en-US" dirty="0"/>
          </a:p>
        </p:txBody>
      </p:sp>
      <p:grpSp>
        <p:nvGrpSpPr>
          <p:cNvPr id="3" name="グループ化 2"/>
          <p:cNvGrpSpPr/>
          <p:nvPr/>
        </p:nvGrpSpPr>
        <p:grpSpPr>
          <a:xfrm>
            <a:off x="1182990" y="1882026"/>
            <a:ext cx="4748659" cy="3434859"/>
            <a:chOff x="1182990" y="2402304"/>
            <a:chExt cx="4748659" cy="3434859"/>
          </a:xfrm>
        </p:grpSpPr>
        <p:sp>
          <p:nvSpPr>
            <p:cNvPr id="36" name="テキスト ボックス 35"/>
            <p:cNvSpPr txBox="1"/>
            <p:nvPr/>
          </p:nvSpPr>
          <p:spPr>
            <a:xfrm>
              <a:off x="1182990" y="2495550"/>
              <a:ext cx="430887" cy="258637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altLang="ja-JP" sz="1600" b="1" dirty="0" err="1" smtClean="0">
                  <a:latin typeface="+mj-lt"/>
                  <a:cs typeface="Arial" pitchFamily="34" charset="0"/>
                </a:rPr>
                <a:t>HAEC</a:t>
              </a:r>
              <a:r>
                <a:rPr lang="en-US" altLang="ja-JP" sz="1600" b="1" dirty="0" smtClean="0">
                  <a:latin typeface="+mj-lt"/>
                  <a:cs typeface="Arial" pitchFamily="34" charset="0"/>
                </a:rPr>
                <a:t> c</a:t>
              </a:r>
              <a:r>
                <a:rPr kumimoji="1" lang="en-US" altLang="ja-JP" sz="1600" b="1" dirty="0" smtClean="0">
                  <a:latin typeface="+mj-lt"/>
                  <a:cs typeface="Arial" pitchFamily="34" charset="0"/>
                </a:rPr>
                <a:t>ell viability (</a:t>
              </a:r>
              <a:r>
                <a:rPr lang="en-US" altLang="ja-JP" sz="1600" b="1" dirty="0" smtClean="0">
                  <a:latin typeface="+mj-lt"/>
                  <a:cs typeface="Arial" pitchFamily="34" charset="0"/>
                </a:rPr>
                <a:t>% control</a:t>
              </a:r>
              <a:r>
                <a:rPr lang="en-US" altLang="ja-JP" sz="1600" b="1" dirty="0">
                  <a:latin typeface="+mj-lt"/>
                  <a:cs typeface="Arial" pitchFamily="34" charset="0"/>
                </a:rPr>
                <a:t>) </a:t>
              </a:r>
              <a:endParaRPr lang="ja-JP" altLang="en-US" sz="1600" b="1" dirty="0">
                <a:latin typeface="+mj-lt"/>
                <a:cs typeface="Arial" pitchFamily="34" charset="0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5242742" y="4972944"/>
              <a:ext cx="68890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+mj-lt"/>
                </a:rPr>
                <a:t>μg/</a:t>
              </a:r>
              <a:r>
                <a:rPr lang="en-US" altLang="ja-JP" sz="1600" dirty="0" smtClean="0">
                  <a:latin typeface="+mj-lt"/>
                </a:rPr>
                <a:t>ml</a:t>
              </a:r>
              <a:endParaRPr kumimoji="1" lang="ja-JP" altLang="en-US" sz="1600" dirty="0">
                <a:latin typeface="+mj-lt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2084284" y="5467831"/>
              <a:ext cx="31559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latin typeface="+mj-lt"/>
                </a:rPr>
                <a:t>CTL        SWCNT             DWCNT</a:t>
              </a:r>
              <a:endParaRPr kumimoji="1" lang="ja-JP" altLang="en-US" b="1" dirty="0">
                <a:latin typeface="+mj-lt"/>
              </a:endParaRPr>
            </a:p>
          </p:txBody>
        </p:sp>
        <p:cxnSp>
          <p:nvCxnSpPr>
            <p:cNvPr id="25" name="直線コネクタ 24"/>
            <p:cNvCxnSpPr/>
            <p:nvPr/>
          </p:nvCxnSpPr>
          <p:spPr>
            <a:xfrm>
              <a:off x="2448483" y="5411826"/>
              <a:ext cx="1367999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/>
            <p:cNvCxnSpPr/>
            <p:nvPr/>
          </p:nvCxnSpPr>
          <p:spPr>
            <a:xfrm>
              <a:off x="3911412" y="5411826"/>
              <a:ext cx="1367999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テキスト ボックス 27"/>
            <p:cNvSpPr txBox="1"/>
            <p:nvPr/>
          </p:nvSpPr>
          <p:spPr>
            <a:xfrm>
              <a:off x="2507454" y="5004131"/>
              <a:ext cx="13260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+mj-lt"/>
                </a:rPr>
                <a:t>2.5     25     50</a:t>
              </a:r>
              <a:endParaRPr kumimoji="1" lang="ja-JP" altLang="en-US" sz="1600" dirty="0">
                <a:latin typeface="+mj-lt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4890385" y="3375518"/>
              <a:ext cx="33795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dirty="0" smtClean="0">
                  <a:latin typeface="+mj-lt"/>
                </a:rPr>
                <a:t>*</a:t>
              </a:r>
              <a:endParaRPr kumimoji="1" lang="ja-JP" altLang="en-US" sz="2400" dirty="0">
                <a:latin typeface="+mj-lt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4448254" y="3093377"/>
              <a:ext cx="33795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dirty="0" smtClean="0">
                  <a:latin typeface="+mj-lt"/>
                </a:rPr>
                <a:t>*</a:t>
              </a:r>
              <a:endParaRPr kumimoji="1" lang="ja-JP" altLang="en-US" sz="2400" dirty="0">
                <a:latin typeface="+mj-lt"/>
              </a:endParaRPr>
            </a:p>
          </p:txBody>
        </p:sp>
        <p:graphicFrame>
          <p:nvGraphicFramePr>
            <p:cNvPr id="52" name="グラフ 5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83697838"/>
                </p:ext>
              </p:extLst>
            </p:nvPr>
          </p:nvGraphicFramePr>
          <p:xfrm>
            <a:off x="1554949" y="2402304"/>
            <a:ext cx="3884398" cy="27241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3" name="テキスト ボックス 52"/>
            <p:cNvSpPr txBox="1"/>
            <p:nvPr/>
          </p:nvSpPr>
          <p:spPr>
            <a:xfrm>
              <a:off x="3954229" y="5002156"/>
              <a:ext cx="13260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>
                  <a:latin typeface="+mj-lt"/>
                </a:rPr>
                <a:t>2.5     25     50</a:t>
              </a:r>
              <a:endParaRPr kumimoji="1" lang="ja-JP" altLang="en-US" sz="1600" dirty="0">
                <a:latin typeface="+mj-lt"/>
              </a:endParaRP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3494835" y="3298184"/>
              <a:ext cx="33795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dirty="0" smtClean="0">
                  <a:latin typeface="+mj-lt"/>
                </a:rPr>
                <a:t>*</a:t>
              </a:r>
              <a:endParaRPr kumimoji="1" lang="ja-JP" altLang="en-US" sz="2400" dirty="0">
                <a:latin typeface="+mj-lt"/>
              </a:endParaRP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3037104" y="2860269"/>
              <a:ext cx="33795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dirty="0" smtClean="0">
                  <a:latin typeface="+mj-lt"/>
                </a:rPr>
                <a:t>*</a:t>
              </a:r>
              <a:endParaRPr kumimoji="1" lang="ja-JP" altLang="en-US" sz="2400" dirty="0">
                <a:latin typeface="+mj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183194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11</TotalTime>
  <Words>99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uzuki yuka</dc:creator>
  <cp:lastModifiedBy>Sahoko Ichihara</cp:lastModifiedBy>
  <cp:revision>95</cp:revision>
  <cp:lastPrinted>2015-04-21T10:39:54Z</cp:lastPrinted>
  <dcterms:created xsi:type="dcterms:W3CDTF">2014-03-05T06:58:53Z</dcterms:created>
  <dcterms:modified xsi:type="dcterms:W3CDTF">2016-10-02T14:47:53Z</dcterms:modified>
</cp:coreProperties>
</file>